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35" autoAdjust="0"/>
  </p:normalViewPr>
  <p:slideViewPr>
    <p:cSldViewPr snapToGrid="0">
      <p:cViewPr varScale="1">
        <p:scale>
          <a:sx n="104" d="100"/>
          <a:sy n="104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han, Man" userId="37104710-05df-4370-9d86-514a293a6e2e" providerId="ADAL" clId="{F8A55050-74ED-45D5-92A7-053B2A482D3A}"/>
    <pc:docChg chg="undo custSel addSld delSld modSld">
      <pc:chgData name="Mohan, Man" userId="37104710-05df-4370-9d86-514a293a6e2e" providerId="ADAL" clId="{F8A55050-74ED-45D5-92A7-053B2A482D3A}" dt="2024-10-15T20:50:49.742" v="33" actId="6549"/>
      <pc:docMkLst>
        <pc:docMk/>
      </pc:docMkLst>
      <pc:sldChg chg="del">
        <pc:chgData name="Mohan, Man" userId="37104710-05df-4370-9d86-514a293a6e2e" providerId="ADAL" clId="{F8A55050-74ED-45D5-92A7-053B2A482D3A}" dt="2024-10-15T20:50:46.174" v="28" actId="47"/>
        <pc:sldMkLst>
          <pc:docMk/>
          <pc:sldMk cId="1121486319" sldId="256"/>
        </pc:sldMkLst>
      </pc:sldChg>
      <pc:sldChg chg="del">
        <pc:chgData name="Mohan, Man" userId="37104710-05df-4370-9d86-514a293a6e2e" providerId="ADAL" clId="{F8A55050-74ED-45D5-92A7-053B2A482D3A}" dt="2024-10-15T20:50:46.341" v="29" actId="47"/>
        <pc:sldMkLst>
          <pc:docMk/>
          <pc:sldMk cId="4205977045" sldId="257"/>
        </pc:sldMkLst>
      </pc:sldChg>
      <pc:sldChg chg="modSp add del mod">
        <pc:chgData name="Mohan, Man" userId="37104710-05df-4370-9d86-514a293a6e2e" providerId="ADAL" clId="{F8A55050-74ED-45D5-92A7-053B2A482D3A}" dt="2024-10-15T20:50:49.742" v="33" actId="6549"/>
        <pc:sldMkLst>
          <pc:docMk/>
          <pc:sldMk cId="3414948269" sldId="258"/>
        </pc:sldMkLst>
        <pc:spChg chg="mod">
          <ac:chgData name="Mohan, Man" userId="37104710-05df-4370-9d86-514a293a6e2e" providerId="ADAL" clId="{F8A55050-74ED-45D5-92A7-053B2A482D3A}" dt="2024-10-15T20:50:49.742" v="33" actId="6549"/>
          <ac:spMkLst>
            <pc:docMk/>
            <pc:sldMk cId="3414948269" sldId="258"/>
            <ac:spMk id="5" creationId="{8CFB2EA7-5BF8-484C-B30D-B4DA248A8998}"/>
          </ac:spMkLst>
        </pc:spChg>
      </pc:sldChg>
      <pc:sldChg chg="del">
        <pc:chgData name="Mohan, Man" userId="37104710-05df-4370-9d86-514a293a6e2e" providerId="ADAL" clId="{F8A55050-74ED-45D5-92A7-053B2A482D3A}" dt="2024-10-11T02:37:52.230" v="0" actId="47"/>
        <pc:sldMkLst>
          <pc:docMk/>
          <pc:sldMk cId="3742170954" sldId="259"/>
        </pc:sldMkLst>
      </pc:sldChg>
      <pc:sldChg chg="del">
        <pc:chgData name="Mohan, Man" userId="37104710-05df-4370-9d86-514a293a6e2e" providerId="ADAL" clId="{F8A55050-74ED-45D5-92A7-053B2A482D3A}" dt="2024-10-11T02:37:53.533" v="1" actId="47"/>
        <pc:sldMkLst>
          <pc:docMk/>
          <pc:sldMk cId="2234559543" sldId="260"/>
        </pc:sldMkLst>
      </pc:sldChg>
      <pc:sldChg chg="del">
        <pc:chgData name="Mohan, Man" userId="37104710-05df-4370-9d86-514a293a6e2e" providerId="ADAL" clId="{F8A55050-74ED-45D5-92A7-053B2A482D3A}" dt="2024-10-11T02:38:04.519" v="23" actId="47"/>
        <pc:sldMkLst>
          <pc:docMk/>
          <pc:sldMk cId="624856637" sldId="261"/>
        </pc:sldMkLst>
      </pc:sldChg>
      <pc:sldChg chg="del">
        <pc:chgData name="Mohan, Man" userId="37104710-05df-4370-9d86-514a293a6e2e" providerId="ADAL" clId="{F8A55050-74ED-45D5-92A7-053B2A482D3A}" dt="2024-10-11T02:38:06.288" v="24" actId="47"/>
        <pc:sldMkLst>
          <pc:docMk/>
          <pc:sldMk cId="2717183306" sldId="262"/>
        </pc:sldMkLst>
      </pc:sldChg>
      <pc:sldChg chg="del">
        <pc:chgData name="Mohan, Man" userId="37104710-05df-4370-9d86-514a293a6e2e" providerId="ADAL" clId="{F8A55050-74ED-45D5-92A7-053B2A482D3A}" dt="2024-10-11T02:38:07.549" v="25" actId="47"/>
        <pc:sldMkLst>
          <pc:docMk/>
          <pc:sldMk cId="870025364" sldId="263"/>
        </pc:sldMkLst>
      </pc:sldChg>
      <pc:sldChg chg="del">
        <pc:chgData name="Mohan, Man" userId="37104710-05df-4370-9d86-514a293a6e2e" providerId="ADAL" clId="{F8A55050-74ED-45D5-92A7-053B2A482D3A}" dt="2024-10-11T02:38:03.333" v="21" actId="47"/>
        <pc:sldMkLst>
          <pc:docMk/>
          <pc:sldMk cId="1131492891" sldId="264"/>
        </pc:sldMkLst>
      </pc:sldChg>
      <pc:sldChg chg="del">
        <pc:chgData name="Mohan, Man" userId="37104710-05df-4370-9d86-514a293a6e2e" providerId="ADAL" clId="{F8A55050-74ED-45D5-92A7-053B2A482D3A}" dt="2024-10-11T02:38:03.965" v="22" actId="47"/>
        <pc:sldMkLst>
          <pc:docMk/>
          <pc:sldMk cId="3674586638" sldId="265"/>
        </pc:sldMkLst>
      </pc:sldChg>
      <pc:sldChg chg="del">
        <pc:chgData name="Mohan, Man" userId="37104710-05df-4370-9d86-514a293a6e2e" providerId="ADAL" clId="{F8A55050-74ED-45D5-92A7-053B2A482D3A}" dt="2024-10-11T02:37:55.556" v="5" actId="47"/>
        <pc:sldMkLst>
          <pc:docMk/>
          <pc:sldMk cId="1261270142" sldId="266"/>
        </pc:sldMkLst>
      </pc:sldChg>
      <pc:sldChg chg="del">
        <pc:chgData name="Mohan, Man" userId="37104710-05df-4370-9d86-514a293a6e2e" providerId="ADAL" clId="{F8A55050-74ED-45D5-92A7-053B2A482D3A}" dt="2024-10-11T02:37:56.028" v="6" actId="47"/>
        <pc:sldMkLst>
          <pc:docMk/>
          <pc:sldMk cId="2399525343" sldId="267"/>
        </pc:sldMkLst>
      </pc:sldChg>
      <pc:sldChg chg="del">
        <pc:chgData name="Mohan, Man" userId="37104710-05df-4370-9d86-514a293a6e2e" providerId="ADAL" clId="{F8A55050-74ED-45D5-92A7-053B2A482D3A}" dt="2024-10-11T02:37:57.023" v="8" actId="47"/>
        <pc:sldMkLst>
          <pc:docMk/>
          <pc:sldMk cId="2260216419" sldId="269"/>
        </pc:sldMkLst>
      </pc:sldChg>
      <pc:sldChg chg="del">
        <pc:chgData name="Mohan, Man" userId="37104710-05df-4370-9d86-514a293a6e2e" providerId="ADAL" clId="{F8A55050-74ED-45D5-92A7-053B2A482D3A}" dt="2024-10-11T02:37:56.566" v="7" actId="47"/>
        <pc:sldMkLst>
          <pc:docMk/>
          <pc:sldMk cId="3194131882" sldId="270"/>
        </pc:sldMkLst>
      </pc:sldChg>
      <pc:sldChg chg="del">
        <pc:chgData name="Mohan, Man" userId="37104710-05df-4370-9d86-514a293a6e2e" providerId="ADAL" clId="{F8A55050-74ED-45D5-92A7-053B2A482D3A}" dt="2024-10-11T02:37:57.577" v="9" actId="47"/>
        <pc:sldMkLst>
          <pc:docMk/>
          <pc:sldMk cId="3011352975" sldId="271"/>
        </pc:sldMkLst>
      </pc:sldChg>
      <pc:sldChg chg="del">
        <pc:chgData name="Mohan, Man" userId="37104710-05df-4370-9d86-514a293a6e2e" providerId="ADAL" clId="{F8A55050-74ED-45D5-92A7-053B2A482D3A}" dt="2024-10-11T02:37:58.068" v="10" actId="47"/>
        <pc:sldMkLst>
          <pc:docMk/>
          <pc:sldMk cId="36225885" sldId="272"/>
        </pc:sldMkLst>
      </pc:sldChg>
      <pc:sldChg chg="del">
        <pc:chgData name="Mohan, Man" userId="37104710-05df-4370-9d86-514a293a6e2e" providerId="ADAL" clId="{F8A55050-74ED-45D5-92A7-053B2A482D3A}" dt="2024-10-11T02:37:58.459" v="11" actId="47"/>
        <pc:sldMkLst>
          <pc:docMk/>
          <pc:sldMk cId="3140328593" sldId="273"/>
        </pc:sldMkLst>
      </pc:sldChg>
      <pc:sldChg chg="del">
        <pc:chgData name="Mohan, Man" userId="37104710-05df-4370-9d86-514a293a6e2e" providerId="ADAL" clId="{F8A55050-74ED-45D5-92A7-053B2A482D3A}" dt="2024-10-11T02:37:58.932" v="12" actId="47"/>
        <pc:sldMkLst>
          <pc:docMk/>
          <pc:sldMk cId="669503856" sldId="274"/>
        </pc:sldMkLst>
      </pc:sldChg>
      <pc:sldChg chg="del">
        <pc:chgData name="Mohan, Man" userId="37104710-05df-4370-9d86-514a293a6e2e" providerId="ADAL" clId="{F8A55050-74ED-45D5-92A7-053B2A482D3A}" dt="2024-10-11T02:37:59.347" v="13" actId="47"/>
        <pc:sldMkLst>
          <pc:docMk/>
          <pc:sldMk cId="3635091487" sldId="275"/>
        </pc:sldMkLst>
      </pc:sldChg>
      <pc:sldChg chg="del">
        <pc:chgData name="Mohan, Man" userId="37104710-05df-4370-9d86-514a293a6e2e" providerId="ADAL" clId="{F8A55050-74ED-45D5-92A7-053B2A482D3A}" dt="2024-10-11T02:37:54.106" v="2" actId="47"/>
        <pc:sldMkLst>
          <pc:docMk/>
          <pc:sldMk cId="2458001602" sldId="281"/>
        </pc:sldMkLst>
      </pc:sldChg>
      <pc:sldChg chg="del">
        <pc:chgData name="Mohan, Man" userId="37104710-05df-4370-9d86-514a293a6e2e" providerId="ADAL" clId="{F8A55050-74ED-45D5-92A7-053B2A482D3A}" dt="2024-10-11T02:37:54.562" v="3" actId="47"/>
        <pc:sldMkLst>
          <pc:docMk/>
          <pc:sldMk cId="285705100" sldId="282"/>
        </pc:sldMkLst>
      </pc:sldChg>
      <pc:sldChg chg="del">
        <pc:chgData name="Mohan, Man" userId="37104710-05df-4370-9d86-514a293a6e2e" providerId="ADAL" clId="{F8A55050-74ED-45D5-92A7-053B2A482D3A}" dt="2024-10-11T02:38:02.733" v="20" actId="47"/>
        <pc:sldMkLst>
          <pc:docMk/>
          <pc:sldMk cId="1149221801" sldId="288"/>
        </pc:sldMkLst>
      </pc:sldChg>
      <pc:sldChg chg="del">
        <pc:chgData name="Mohan, Man" userId="37104710-05df-4370-9d86-514a293a6e2e" providerId="ADAL" clId="{F8A55050-74ED-45D5-92A7-053B2A482D3A}" dt="2024-10-11T02:37:59.784" v="14" actId="47"/>
        <pc:sldMkLst>
          <pc:docMk/>
          <pc:sldMk cId="1285376761" sldId="500"/>
        </pc:sldMkLst>
      </pc:sldChg>
      <pc:sldChg chg="del">
        <pc:chgData name="Mohan, Man" userId="37104710-05df-4370-9d86-514a293a6e2e" providerId="ADAL" clId="{F8A55050-74ED-45D5-92A7-053B2A482D3A}" dt="2024-10-11T02:38:01.991" v="19" actId="47"/>
        <pc:sldMkLst>
          <pc:docMk/>
          <pc:sldMk cId="3620413559" sldId="501"/>
        </pc:sldMkLst>
      </pc:sldChg>
      <pc:sldChg chg="del">
        <pc:chgData name="Mohan, Man" userId="37104710-05df-4370-9d86-514a293a6e2e" providerId="ADAL" clId="{F8A55050-74ED-45D5-92A7-053B2A482D3A}" dt="2024-10-11T02:38:01.472" v="18" actId="47"/>
        <pc:sldMkLst>
          <pc:docMk/>
          <pc:sldMk cId="4122175436" sldId="502"/>
        </pc:sldMkLst>
      </pc:sldChg>
      <pc:sldChg chg="del">
        <pc:chgData name="Mohan, Man" userId="37104710-05df-4370-9d86-514a293a6e2e" providerId="ADAL" clId="{F8A55050-74ED-45D5-92A7-053B2A482D3A}" dt="2024-10-11T02:37:55.004" v="4" actId="47"/>
        <pc:sldMkLst>
          <pc:docMk/>
          <pc:sldMk cId="1477486496" sldId="503"/>
        </pc:sldMkLst>
      </pc:sldChg>
      <pc:sldChg chg="del">
        <pc:chgData name="Mohan, Man" userId="37104710-05df-4370-9d86-514a293a6e2e" providerId="ADAL" clId="{F8A55050-74ED-45D5-92A7-053B2A482D3A}" dt="2024-10-11T02:38:01.092" v="17" actId="47"/>
        <pc:sldMkLst>
          <pc:docMk/>
          <pc:sldMk cId="2721794196" sldId="504"/>
        </pc:sldMkLst>
      </pc:sldChg>
      <pc:sldChg chg="del">
        <pc:chgData name="Mohan, Man" userId="37104710-05df-4370-9d86-514a293a6e2e" providerId="ADAL" clId="{F8A55050-74ED-45D5-92A7-053B2A482D3A}" dt="2024-10-11T02:38:00.164" v="15" actId="47"/>
        <pc:sldMkLst>
          <pc:docMk/>
          <pc:sldMk cId="4210385526" sldId="505"/>
        </pc:sldMkLst>
      </pc:sldChg>
      <pc:sldChg chg="del">
        <pc:chgData name="Mohan, Man" userId="37104710-05df-4370-9d86-514a293a6e2e" providerId="ADAL" clId="{F8A55050-74ED-45D5-92A7-053B2A482D3A}" dt="2024-10-11T02:38:00.604" v="16" actId="47"/>
        <pc:sldMkLst>
          <pc:docMk/>
          <pc:sldMk cId="1656193735" sldId="50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504583-7B5D-40B4-9C6F-03C96B52897B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F89A4-67EE-4C74-A11B-3F43D8EA81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949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EA70D-3707-46A2-A485-AAE86DFEAE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7700330-E2EA-4D07-9D93-6710457747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51315-0B1E-43F9-9181-336A19B8D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0363D5-A7B9-4777-93AE-2F78C0E5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5CC34B-092D-4C7A-ABA2-7552E9E89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06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D26CF-1A19-45F2-B9DE-47DACDF40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606D00C-F753-487F-8B5C-1AE84AF89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689296-4539-4176-8256-C61131A77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2E0E34-1DD3-4652-86A3-272AD902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E8106D-F029-4780-9715-81C5A3FD3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438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F712C04-2146-4D64-8941-528041968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7675B9D-DC94-4AB1-ADC7-1BD6803BC2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F9DBB-0DCF-49BD-A524-63B90012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36DF19-A71D-406E-83ED-36C474FF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EE3502-7F4C-40E8-9072-8D28BB2B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94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A59159-B982-4394-B832-096011BD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255ADB8-D7D1-4FA2-8B4D-5DAB5EC21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E22A4-94EA-4DE4-A2F6-1DAA60B4D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E490B2-C4E2-4EF1-BEEB-035A80420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403662-B430-46BC-84C7-D808814BB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4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886453-A168-4680-9E8C-2D74DDE3F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60B88F-6DCF-40CB-B65D-D2BA7229B5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C47B9E-13A4-4FFB-98B3-5200E2BE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615512-68D1-4687-A658-0DFE754D8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D8E0FE-E8F3-4654-8656-476144260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236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F2729F-3944-4F03-8032-39F1881B0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580B50-8709-4DC7-931B-352534FAC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6A69BC4-6C28-435C-BEC9-37327CD357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1C899A-4A23-4DC8-9263-3AC966252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F9BEAA-D690-4733-A7B5-CE9BC17AF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251231-C7BD-4230-8B08-2A2F9FAB3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66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986141-A74D-4E71-AD24-48A53384D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17FE55-8D4B-4B3F-9FC0-400251B8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E5E27D-98DE-46D6-BF5D-57A3AAD70E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A70CE71-2E40-46E3-B367-23C8A8B21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22EBE65-BAD6-4ED3-8E88-A0CA6FDBC6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43C7EFC-D303-40E7-B4A4-A2C6BFDD3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B705BD2-8602-47E6-A9E6-4656F4AB8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B80679-178B-4860-852C-CFE1D4F7F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9F88B0-9D19-4FF4-9AC7-77BACEDD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367C5E-C6BC-400A-BB13-5D0E2F508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A2583F3-DC24-4165-88D9-FF7F5600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576730E-E551-423C-BD86-5115AF82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81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D1F254-FC85-4D1C-AF6C-8DE072BD7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902D72B-1EEE-4861-8A8B-530642722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5538E7B-789C-49FA-805A-C1529D404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20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0470EA-7D03-4725-BA05-E7CE1E37B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257138-28FB-406B-8438-46576CF45C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810CDF-550A-47EC-BCFD-81389CE8B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212A10F-B061-4FBD-ADDF-DD9DCCA9C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4E30AC-E221-4572-99C0-A2FE3705F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98A571-57FC-44B6-AA2A-D25267604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92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7F52C-996E-4B46-9605-FFFFA8F3C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7F9AB88-D2AF-4315-87D0-C91C24BC19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DF98DF-667B-425A-9325-7B86ECD841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F2C9590-6A3B-472D-89D3-D2D5DBCFF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7AF6B6-4A12-4C7A-8030-6C9BC894A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AD1C17-E2C4-4CFF-BB6E-AB9662D9D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645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A8FAC-FE6A-4130-A3C5-BA0800FDB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9F49C-7723-4261-9EC6-BB0F23F8F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60EDE9-BE75-4900-AD13-3D691B6CE6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96FF7-876F-4EA9-BBAC-DF2E440F92E8}" type="datetimeFigureOut">
              <a:rPr lang="zh-CN" altLang="en-US" smtClean="0"/>
              <a:t>2024/10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673029-6A76-4353-8913-376FE3904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E15938-83DD-4F7E-9CAC-EDDA39E14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EB121-6F02-423B-B10B-108D809B05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483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D0A64AA5-D988-4589-B92B-C18FBB82B6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5325" y="1192187"/>
            <a:ext cx="1933045" cy="476213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CFB2EA7-5BF8-484C-B30D-B4DA248A8998}"/>
              </a:ext>
            </a:extLst>
          </p:cNvPr>
          <p:cNvSpPr txBox="1"/>
          <p:nvPr/>
        </p:nvSpPr>
        <p:spPr>
          <a:xfrm>
            <a:off x="728221" y="578904"/>
            <a:ext cx="60944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/>
              <a:t>E </a:t>
            </a:r>
            <a:r>
              <a:rPr lang="en-US" altLang="zh-CN" dirty="0"/>
              <a:t>Dyrk1a sgRNA–NIH3T3</a:t>
            </a:r>
          </a:p>
          <a:p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456DDBE-D6B7-409B-B877-50F94E541E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960331" y="1166942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gRNA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17D2924-B0BA-4396-8AB5-45D00F69054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641870" y="1166947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gRNA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EC5DAEEF-BAA6-4EA1-8104-EB7AAE9BEF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7770" y="1149821"/>
            <a:ext cx="1635347" cy="474911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B7B7F46-2DE1-4230-94E7-19BFF8CD54F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036263" y="1166942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gRN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DF540F1-C318-417E-98FB-A7C355996E7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571887" y="1157506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gRNA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9E5AC35-92E7-4F5D-B7C3-98DE155645AD}"/>
              </a:ext>
            </a:extLst>
          </p:cNvPr>
          <p:cNvSpPr txBox="1"/>
          <p:nvPr/>
        </p:nvSpPr>
        <p:spPr>
          <a:xfrm>
            <a:off x="3572962" y="3641272"/>
            <a:ext cx="152646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DYRK1A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BE26775-0B0D-4221-A47B-D36FF83F0D26}"/>
              </a:ext>
            </a:extLst>
          </p:cNvPr>
          <p:cNvSpPr txBox="1"/>
          <p:nvPr/>
        </p:nvSpPr>
        <p:spPr>
          <a:xfrm>
            <a:off x="3572962" y="4280268"/>
            <a:ext cx="11009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α-ACTIN</a:t>
            </a:r>
            <a:endParaRPr lang="zh-CN" altLang="en-US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6DFFD2E1-2A98-493D-9759-D59CDF6327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8826" y="4188186"/>
            <a:ext cx="2116505" cy="600630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B35508EC-E37F-4E63-826E-42F47521C88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56688" y="2394837"/>
            <a:ext cx="1729771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Control sgRNA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E9E242E-C805-4138-8342-B832D96EDEC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38227" y="2394842"/>
            <a:ext cx="172976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1600" dirty="0"/>
              <a:t>Dyrk1a sgRNA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1C99A84-8AE2-47C3-87B7-FC0C4DE0EFD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8883" y="3403214"/>
            <a:ext cx="2184079" cy="6913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431231F-FAC6-6898-67F2-0FE54769A514}"/>
              </a:ext>
            </a:extLst>
          </p:cNvPr>
          <p:cNvSpPr txBox="1"/>
          <p:nvPr/>
        </p:nvSpPr>
        <p:spPr>
          <a:xfrm>
            <a:off x="8858659" y="192410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6A5E130-5272-5513-B9C6-9245EFF47E26}"/>
              </a:ext>
            </a:extLst>
          </p:cNvPr>
          <p:cNvSpPr txBox="1"/>
          <p:nvPr/>
        </p:nvSpPr>
        <p:spPr>
          <a:xfrm>
            <a:off x="8876841" y="2276198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D7B1C4-C3A0-A4EA-DAAE-4775C3E77104}"/>
              </a:ext>
            </a:extLst>
          </p:cNvPr>
          <p:cNvSpPr txBox="1"/>
          <p:nvPr/>
        </p:nvSpPr>
        <p:spPr>
          <a:xfrm>
            <a:off x="8858659" y="3231774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4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45FE93-3FCD-9321-A3B1-120F9DE0851A}"/>
              </a:ext>
            </a:extLst>
          </p:cNvPr>
          <p:cNvSpPr txBox="1"/>
          <p:nvPr/>
        </p:nvSpPr>
        <p:spPr>
          <a:xfrm>
            <a:off x="8349002" y="36880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128A592-CAEE-5DD5-DBD3-E61B651A9D33}"/>
              </a:ext>
            </a:extLst>
          </p:cNvPr>
          <p:cNvSpPr txBox="1"/>
          <p:nvPr/>
        </p:nvSpPr>
        <p:spPr>
          <a:xfrm>
            <a:off x="8367184" y="4668239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8B1DA56-AE3D-3760-6655-501495121C35}"/>
              </a:ext>
            </a:extLst>
          </p:cNvPr>
          <p:cNvSpPr txBox="1"/>
          <p:nvPr/>
        </p:nvSpPr>
        <p:spPr>
          <a:xfrm>
            <a:off x="8378370" y="270791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3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F17931-3DB5-679E-A5A6-D2A5E76ABDAD}"/>
              </a:ext>
            </a:extLst>
          </p:cNvPr>
          <p:cNvSpPr txBox="1"/>
          <p:nvPr/>
        </p:nvSpPr>
        <p:spPr>
          <a:xfrm>
            <a:off x="8834718" y="2664588"/>
            <a:ext cx="410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63</a:t>
            </a:r>
          </a:p>
        </p:txBody>
      </p:sp>
    </p:spTree>
    <p:extLst>
      <p:ext uri="{BB962C8B-B14F-4D97-AF65-F5344CB8AC3E}">
        <p14:creationId xmlns:p14="http://schemas.microsoft.com/office/powerpoint/2010/main" val="3414948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2</TotalTime>
  <Words>26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inhua Wang</dc:creator>
  <cp:lastModifiedBy>Mohan, Man</cp:lastModifiedBy>
  <cp:revision>18</cp:revision>
  <dcterms:created xsi:type="dcterms:W3CDTF">2022-02-25T12:50:45Z</dcterms:created>
  <dcterms:modified xsi:type="dcterms:W3CDTF">2024-10-15T20:50:51Z</dcterms:modified>
</cp:coreProperties>
</file>